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168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C5B0C-2542-4BA2-915A-E2D4EFC0FFB7}" type="datetimeFigureOut">
              <a:rPr lang="en-GB" smtClean="0"/>
              <a:t>06/0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A9A07-56C8-4A19-B0C6-75C4AFD621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13791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C5B0C-2542-4BA2-915A-E2D4EFC0FFB7}" type="datetimeFigureOut">
              <a:rPr lang="en-GB" smtClean="0"/>
              <a:t>06/0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A9A07-56C8-4A19-B0C6-75C4AFD621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59322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C5B0C-2542-4BA2-915A-E2D4EFC0FFB7}" type="datetimeFigureOut">
              <a:rPr lang="en-GB" smtClean="0"/>
              <a:t>06/0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A9A07-56C8-4A19-B0C6-75C4AFD621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5155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C5B0C-2542-4BA2-915A-E2D4EFC0FFB7}" type="datetimeFigureOut">
              <a:rPr lang="en-GB" smtClean="0"/>
              <a:t>06/0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A9A07-56C8-4A19-B0C6-75C4AFD621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98098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C5B0C-2542-4BA2-915A-E2D4EFC0FFB7}" type="datetimeFigureOut">
              <a:rPr lang="en-GB" smtClean="0"/>
              <a:t>06/0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A9A07-56C8-4A19-B0C6-75C4AFD621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2119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C5B0C-2542-4BA2-915A-E2D4EFC0FFB7}" type="datetimeFigureOut">
              <a:rPr lang="en-GB" smtClean="0"/>
              <a:t>06/02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A9A07-56C8-4A19-B0C6-75C4AFD621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95119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C5B0C-2542-4BA2-915A-E2D4EFC0FFB7}" type="datetimeFigureOut">
              <a:rPr lang="en-GB" smtClean="0"/>
              <a:t>06/02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A9A07-56C8-4A19-B0C6-75C4AFD621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87419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C5B0C-2542-4BA2-915A-E2D4EFC0FFB7}" type="datetimeFigureOut">
              <a:rPr lang="en-GB" smtClean="0"/>
              <a:t>06/02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A9A07-56C8-4A19-B0C6-75C4AFD621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2630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C5B0C-2542-4BA2-915A-E2D4EFC0FFB7}" type="datetimeFigureOut">
              <a:rPr lang="en-GB" smtClean="0"/>
              <a:t>06/02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A9A07-56C8-4A19-B0C6-75C4AFD621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4930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C5B0C-2542-4BA2-915A-E2D4EFC0FFB7}" type="datetimeFigureOut">
              <a:rPr lang="en-GB" smtClean="0"/>
              <a:t>06/02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A9A07-56C8-4A19-B0C6-75C4AFD621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32692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C5B0C-2542-4BA2-915A-E2D4EFC0FFB7}" type="datetimeFigureOut">
              <a:rPr lang="en-GB" smtClean="0"/>
              <a:t>06/02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A9A07-56C8-4A19-B0C6-75C4AFD621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2122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FC5B0C-2542-4BA2-915A-E2D4EFC0FFB7}" type="datetimeFigureOut">
              <a:rPr lang="en-GB" smtClean="0"/>
              <a:t>06/0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9A9A07-56C8-4A19-B0C6-75C4AFD621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00023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90775" y="188640"/>
            <a:ext cx="4362450" cy="5524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40325" y="5589240"/>
            <a:ext cx="858014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Supplemental figure 1: </a:t>
            </a:r>
            <a:r>
              <a:rPr lang="en-GB" dirty="0"/>
              <a:t>SDS-PAGE analysis of purified </a:t>
            </a:r>
            <a:r>
              <a:rPr lang="en-GB" i="1" dirty="0"/>
              <a:t>Campylobacter </a:t>
            </a:r>
            <a:r>
              <a:rPr lang="en-GB" i="1" dirty="0" err="1"/>
              <a:t>jejuni</a:t>
            </a:r>
            <a:r>
              <a:rPr lang="en-GB" i="1" dirty="0"/>
              <a:t> </a:t>
            </a:r>
            <a:r>
              <a:rPr lang="en-GB" dirty="0" err="1" smtClean="0"/>
              <a:t>flagellin</a:t>
            </a:r>
            <a:r>
              <a:rPr lang="en-GB" dirty="0" smtClean="0"/>
              <a:t> protein</a:t>
            </a:r>
            <a:r>
              <a:rPr lang="en-GB" dirty="0"/>
              <a:t>. 10% SDS-PAGE gel, stained with </a:t>
            </a:r>
            <a:r>
              <a:rPr lang="en-GB" dirty="0" err="1"/>
              <a:t>Coomassie</a:t>
            </a:r>
            <a:r>
              <a:rPr lang="en-GB" dirty="0"/>
              <a:t> blue. Lane 1 – </a:t>
            </a:r>
            <a:r>
              <a:rPr lang="en-GB" dirty="0" smtClean="0"/>
              <a:t>MW markers. </a:t>
            </a:r>
            <a:r>
              <a:rPr lang="en-GB" dirty="0"/>
              <a:t>Lane 2 – cell suspension from </a:t>
            </a:r>
            <a:r>
              <a:rPr lang="en-GB" i="1" dirty="0"/>
              <a:t>C. </a:t>
            </a:r>
            <a:r>
              <a:rPr lang="en-GB" i="1" dirty="0" err="1"/>
              <a:t>jejuni</a:t>
            </a:r>
            <a:r>
              <a:rPr lang="en-GB" i="1" dirty="0"/>
              <a:t> </a:t>
            </a:r>
            <a:r>
              <a:rPr lang="en-GB" dirty="0"/>
              <a:t>strain 11168 culture, Lane 3 – purified </a:t>
            </a:r>
            <a:r>
              <a:rPr lang="en-GB" dirty="0" err="1" smtClean="0"/>
              <a:t>flagellin</a:t>
            </a:r>
            <a:r>
              <a:rPr lang="en-GB" dirty="0" smtClean="0"/>
              <a:t> </a:t>
            </a:r>
            <a:r>
              <a:rPr lang="en-GB" dirty="0"/>
              <a:t>protein </a:t>
            </a:r>
          </a:p>
        </p:txBody>
      </p:sp>
    </p:spTree>
    <p:extLst>
      <p:ext uri="{BB962C8B-B14F-4D97-AF65-F5344CB8AC3E}">
        <p14:creationId xmlns:p14="http://schemas.microsoft.com/office/powerpoint/2010/main" val="5410479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8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Birmingha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 Cooper</dc:creator>
  <cp:lastModifiedBy>Helen Cooper</cp:lastModifiedBy>
  <cp:revision>1</cp:revision>
  <dcterms:created xsi:type="dcterms:W3CDTF">2015-01-19T14:55:20Z</dcterms:created>
  <dcterms:modified xsi:type="dcterms:W3CDTF">2015-02-06T16:19:24Z</dcterms:modified>
</cp:coreProperties>
</file>